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slides/slide14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bin" ContentType="application/vnd.openxmlformats-officedocument.presentationml.printerSettings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Default Extension="jpeg" ContentType="image/jpeg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Layouts/slideLayout3.xml" ContentType="application/vnd.openxmlformats-officedocument.presentationml.slideLayout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48" r:id="rId1"/>
  </p:sldMasterIdLst>
  <p:sldIdLst>
    <p:sldId id="256" r:id="rId2"/>
    <p:sldId id="261" r:id="rId3"/>
    <p:sldId id="278" r:id="rId4"/>
    <p:sldId id="277" r:id="rId5"/>
    <p:sldId id="262" r:id="rId6"/>
    <p:sldId id="263" r:id="rId7"/>
    <p:sldId id="264" r:id="rId8"/>
    <p:sldId id="265" r:id="rId9"/>
    <p:sldId id="267" r:id="rId10"/>
    <p:sldId id="268" r:id="rId11"/>
    <p:sldId id="269" r:id="rId12"/>
    <p:sldId id="270" r:id="rId13"/>
    <p:sldId id="271" r:id="rId14"/>
    <p:sldId id="272" r:id="rId15"/>
    <p:sldId id="273" r:id="rId16"/>
    <p:sldId id="274" r:id="rId17"/>
    <p:sldId id="275" r:id="rId18"/>
    <p:sldId id="276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chard" initials="R" lastIdx="0" clrIdx="0">
    <p:extLst>
      <p:ext uri="{19B8F6BF-5375-455C-9EA6-DF929625EA0E}">
        <p15:presenceInfo xmlns="" xmlns:p15="http://schemas.microsoft.com/office/powerpoint/2012/main" userId="Richard" providerId="None"/>
      </p:ext>
    </p:extLst>
  </p:cmAuthor>
  <p:cmAuthor id="2" name="Andrew Varley" initials="AV" lastIdx="7" clrIdx="1">
    <p:extLst>
      <p:ext uri="{19B8F6BF-5375-455C-9EA6-DF929625EA0E}">
        <p15:presenceInfo xmlns="" xmlns:p15="http://schemas.microsoft.com/office/powerpoint/2012/main" userId="fc613f7bc5cf631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-568" y="-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8" Type="http://schemas.openxmlformats.org/officeDocument/2006/relationships/slide" Target="slides/slide7.xml"/><Relationship Id="rId26" Type="http://schemas.openxmlformats.org/officeDocument/2006/relationships/customXml" Target="../customXml/item1.xml"/><Relationship Id="rId21" Type="http://schemas.openxmlformats.org/officeDocument/2006/relationships/commentAuthors" Target="commentAuthors.xml"/><Relationship Id="rId3" Type="http://schemas.openxmlformats.org/officeDocument/2006/relationships/slide" Target="slides/slide2.xml"/><Relationship Id="rId25" Type="http://schemas.openxmlformats.org/officeDocument/2006/relationships/tableStyles" Target="tableStyles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7" Type="http://schemas.openxmlformats.org/officeDocument/2006/relationships/slide" Target="slides/slide6.xml"/><Relationship Id="rId20" Type="http://schemas.openxmlformats.org/officeDocument/2006/relationships/printerSettings" Target="printerSettings/printerSettings1.bin"/><Relationship Id="rId16" Type="http://schemas.openxmlformats.org/officeDocument/2006/relationships/slide" Target="slides/slide15.xml"/><Relationship Id="rId2" Type="http://schemas.openxmlformats.org/officeDocument/2006/relationships/slide" Target="slides/slide1.xml"/><Relationship Id="rId24" Type="http://schemas.openxmlformats.org/officeDocument/2006/relationships/theme" Target="theme/theme1.xml"/><Relationship Id="rId11" Type="http://schemas.openxmlformats.org/officeDocument/2006/relationships/slide" Target="slides/slide1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23" Type="http://schemas.openxmlformats.org/officeDocument/2006/relationships/viewProps" Target="viewProps.xml"/><Relationship Id="rId15" Type="http://schemas.openxmlformats.org/officeDocument/2006/relationships/slide" Target="slides/slide14.xml"/><Relationship Id="rId5" Type="http://schemas.openxmlformats.org/officeDocument/2006/relationships/slide" Target="slides/slide4.xml"/><Relationship Id="rId28" Type="http://schemas.openxmlformats.org/officeDocument/2006/relationships/customXml" Target="../customXml/item3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9" Type="http://schemas.openxmlformats.org/officeDocument/2006/relationships/slide" Target="slides/slide8.xml"/><Relationship Id="rId22" Type="http://schemas.openxmlformats.org/officeDocument/2006/relationships/presProps" Target="presProps.xml"/><Relationship Id="rId14" Type="http://schemas.openxmlformats.org/officeDocument/2006/relationships/slide" Target="slides/slide13.xml"/><Relationship Id="rId4" Type="http://schemas.openxmlformats.org/officeDocument/2006/relationships/slide" Target="slides/slide3.xml"/><Relationship Id="rId27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539035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873975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25470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526990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412843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033659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311314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757730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050226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155027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379819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7A542F-8953-4F12-8C16-903FBEB2D140}" type="datetimeFigureOut">
              <a:rPr lang="en-CA" smtClean="0"/>
              <a:t>15-11-18</a:t>
            </a:fld>
            <a:endParaRPr lang="en-CA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EEFE2-A7FD-41FF-90B7-1355CF831E4F}" type="slidenum">
              <a:rPr lang="en-CA" smtClean="0"/>
              <a:t>‹#›</a:t>
            </a:fld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261176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Relationship Id="rId3" Type="http://schemas.openxmlformats.org/officeDocument/2006/relationships/image" Target="../media/image15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png"/><Relationship Id="rId3" Type="http://schemas.openxmlformats.org/officeDocument/2006/relationships/image" Target="../media/image17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png"/><Relationship Id="rId3" Type="http://schemas.openxmlformats.org/officeDocument/2006/relationships/image" Target="../media/image19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.png"/><Relationship Id="rId3" Type="http://schemas.openxmlformats.org/officeDocument/2006/relationships/image" Target="../media/image21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png"/><Relationship Id="rId3" Type="http://schemas.openxmlformats.org/officeDocument/2006/relationships/image" Target="../media/image2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.png"/><Relationship Id="rId3" Type="http://schemas.openxmlformats.org/officeDocument/2006/relationships/image" Target="../media/image25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tiff"/><Relationship Id="rId3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Relationship Id="rId3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png"/><Relationship Id="rId3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Relationship Id="rId3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7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</a:t>
            </a: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2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tohormone ethylene enhances </a:t>
            </a: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ulose </a:t>
            </a:r>
            <a:r>
              <a:rPr lang="en-US" sz="2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tion, regulates CRP/FNR transcription, and causes differential gene expression within </a:t>
            </a: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acterial </a:t>
            </a:r>
            <a:r>
              <a:rPr lang="en-US" sz="2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ose synthesis operon of </a:t>
            </a:r>
            <a:r>
              <a:rPr lang="en-US" sz="27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magataeibacter</a:t>
            </a:r>
            <a:r>
              <a:rPr lang="en-US" sz="2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7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nacetobacter</a:t>
            </a: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27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7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ylinus</a:t>
            </a:r>
            <a:r>
              <a:rPr lang="en-US" sz="27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 </a:t>
            </a:r>
            <a:r>
              <a:rPr lang="en-US" sz="2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3582</a:t>
            </a:r>
            <a:endParaRPr lang="en-CA" sz="2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02088"/>
            <a:ext cx="9144000" cy="1655762"/>
          </a:xfrm>
        </p:spPr>
        <p:txBody>
          <a:bodyPr>
            <a:noAutofit/>
          </a:bodyPr>
          <a:lstStyle/>
          <a:p>
            <a:pPr algn="l"/>
            <a:r>
              <a:rPr lang="en-CA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hard V. Augimeri</a:t>
            </a:r>
            <a:r>
              <a:rPr lang="en-CA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Janice L. Strap</a:t>
            </a:r>
            <a:r>
              <a:rPr lang="en-CA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*</a:t>
            </a:r>
          </a:p>
          <a:p>
            <a:pPr algn="l"/>
            <a:endParaRPr lang="en-CA" b="1" baseline="30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Microbial Biochemistry Laboratory, Faculty of Science, University of Ontario Institute of Technology, Oshawa, ON, Canada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en-CA" b="1" baseline="30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nice L. Strap: janice.strap@uoit.ca</a:t>
            </a:r>
            <a:endParaRPr lang="en-CA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C:\Users\Elaine.Scott\Documents\LaTex\____TEST____Frontiers_LaTeX_Templates_V2.5\Frontiers LaTeX (Science, Health and Engineering) V2.5 - with Supplementary material (V1.2)\logo1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9451" y="398463"/>
            <a:ext cx="3006598" cy="1080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6129544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sC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384217" y="995359"/>
            <a:ext cx="11641188" cy="3312000"/>
            <a:chOff x="1982208" y="1985959"/>
            <a:chExt cx="8098218" cy="230400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82208" y="1985959"/>
              <a:ext cx="4037703" cy="2304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19911" y="1985959"/>
              <a:ext cx="4060515" cy="2304000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87059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sD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384217" y="1103091"/>
            <a:ext cx="11641188" cy="3312000"/>
            <a:chOff x="2458348" y="1985960"/>
            <a:chExt cx="8098218" cy="2304000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96051" y="1985960"/>
              <a:ext cx="4060515" cy="2304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58348" y="1985960"/>
              <a:ext cx="4037703" cy="230400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70692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0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cAx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373286" y="1069363"/>
            <a:ext cx="11663050" cy="3312000"/>
            <a:chOff x="2359297" y="1794576"/>
            <a:chExt cx="8113426" cy="230400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59297" y="1794576"/>
              <a:ext cx="4052911" cy="2304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12208" y="1794576"/>
              <a:ext cx="4060515" cy="2304000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94098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1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pAx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378751" y="976310"/>
            <a:ext cx="11652119" cy="3312000"/>
            <a:chOff x="1986415" y="1985960"/>
            <a:chExt cx="8105822" cy="2304000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86415" y="1985960"/>
              <a:ext cx="4037703" cy="2304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24118" y="1985960"/>
              <a:ext cx="4068119" cy="230400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17632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2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glAx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378751" y="992917"/>
            <a:ext cx="11652119" cy="3312000"/>
            <a:chOff x="1619891" y="2001910"/>
            <a:chExt cx="8105822" cy="230400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19891" y="2001910"/>
              <a:ext cx="4052911" cy="2304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72802" y="2001910"/>
              <a:ext cx="4052911" cy="2304000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94881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3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p/fnr</a:t>
            </a:r>
            <a:r>
              <a:rPr lang="en-US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x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373286" y="1133522"/>
            <a:ext cx="11663050" cy="3312000"/>
            <a:chOff x="1936837" y="1890267"/>
            <a:chExt cx="8113426" cy="2304000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36837" y="1890267"/>
              <a:ext cx="4045307" cy="2304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82144" y="1890267"/>
              <a:ext cx="4068119" cy="230400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31493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03418" y="2318616"/>
            <a:ext cx="5695950" cy="1325563"/>
          </a:xfrm>
        </p:spPr>
        <p:txBody>
          <a:bodyPr/>
          <a:lstStyle/>
          <a:p>
            <a:r>
              <a:rPr lang="en-CA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s</a:t>
            </a:r>
            <a:endParaRPr lang="en-CA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37815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81115" y="5842337"/>
            <a:ext cx="76399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CA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kumimoji="0" lang="en-CA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s the strains of </a:t>
            </a:r>
            <a:r>
              <a:rPr kumimoji="0" lang="en-CA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. xylinus </a:t>
            </a:r>
            <a:r>
              <a:rPr kumimoji="0" lang="en-CA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hose genome sequences were used to design each primer set</a:t>
            </a:r>
            <a:endParaRPr kumimoji="0" lang="en-CA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CA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kumimoji="0" lang="en-CA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se locus tags identify each gene and can be found within the genome sequences of the respective </a:t>
            </a:r>
            <a:r>
              <a:rPr kumimoji="0" lang="en-CA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. xylinus</a:t>
            </a:r>
            <a:r>
              <a:rPr kumimoji="0" lang="en-CA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rain. </a:t>
            </a:r>
            <a:endParaRPr kumimoji="0" lang="en-CA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CA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</a:t>
            </a:r>
            <a:r>
              <a:rPr kumimoji="0" lang="en-CA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cus tag- Genome accession: AP012159.1</a:t>
            </a:r>
            <a:endParaRPr kumimoji="0" lang="en-CA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CA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 </a:t>
            </a:r>
            <a:r>
              <a:rPr kumimoji="0" lang="en-CA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cus tag- Genome accession: CP004360.1</a:t>
            </a:r>
            <a:endParaRPr kumimoji="0" lang="en-CA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CA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 </a:t>
            </a:r>
            <a:r>
              <a:rPr kumimoji="0" lang="en-CA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accession number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9289" y="292769"/>
            <a:ext cx="7194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en-US" b="1" i="0" u="none" strike="noStrike" cap="none" normalizeH="0" baseline="0" dirty="0" smtClean="0" bmk="_Toc426505963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</a:t>
            </a:r>
            <a:r>
              <a:rPr kumimoji="0" lang="en-US" altLang="en-US" b="1" i="0" u="none" strike="noStrike" cap="none" normalizeH="0" dirty="0" smtClean="0" bmk="_Toc426505963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able 1. </a:t>
            </a:r>
            <a:r>
              <a:rPr kumimoji="0" lang="en-US" altLang="en-US" i="0" u="none" strike="noStrike" cap="none" normalizeH="0" baseline="0" dirty="0" smtClean="0" bmk="_Toc426505963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tails of primer sets used in this study.</a:t>
            </a:r>
            <a:endParaRPr lang="en-CA" dirty="0"/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9588327"/>
              </p:ext>
            </p:extLst>
          </p:nvPr>
        </p:nvGraphicFramePr>
        <p:xfrm>
          <a:off x="109289" y="950571"/>
          <a:ext cx="11924141" cy="4891766"/>
        </p:xfrm>
        <a:graphic>
          <a:graphicData uri="http://schemas.openxmlformats.org/drawingml/2006/table">
            <a:tbl>
              <a:tblPr firstRow="1" firstCol="1" bandRow="1"/>
              <a:tblGrid>
                <a:gridCol w="1221266"/>
                <a:gridCol w="747747"/>
                <a:gridCol w="1068421"/>
                <a:gridCol w="1526383"/>
                <a:gridCol w="1520859"/>
                <a:gridCol w="2940084"/>
                <a:gridCol w="2899381"/>
              </a:tblGrid>
              <a:tr h="455048"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sign Strain</a:t>
                      </a:r>
                      <a:r>
                        <a:rPr lang="en-US" sz="1200" b="1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cession/Locus Tag</a:t>
                      </a:r>
                      <a:r>
                        <a:rPr lang="en-US" sz="1200" b="1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plicon length (bp)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ward primer sequence (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→3</a:t>
                      </a: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’)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verse primer sequence (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→3</a:t>
                      </a: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’)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rowSpan="2"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ference Genes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SrRN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BRC 3288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X_r0020</a:t>
                      </a:r>
                      <a:r>
                        <a:rPr lang="en-CA" sz="12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AGCTGGGTTTAGAACGTCGTG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ACCTGGCCTATTGACGTGATG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yrB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2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845_869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8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TCGTCACAGACCAAGGACAAG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TCCTTGGGGTGGGTTTCAAAC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1286">
                <a:tc rowSpan="8"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 Genes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5358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54676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CAATGGGCTGGATGGTCG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CCCGCAAAAGAAGGTCGC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B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5358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54676.1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7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TGCGTTCCATCTTGGGCTTGAC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AGGTCAAGATAGGCGCCAAC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C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5358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54676.1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3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CCAGTCGCATATCGGCAATCGT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GGTCGTTCAACTGGCTTTCAT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D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5358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54676.1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3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ACCCTGTTTCTTCAGACCCTGT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AGTTCGATCTGCAGCTTGTCC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mcA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5358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91058.1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CCAACCTGCAGCATACCAATG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CCATCTGTGGCATTGTTCTTGT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pA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5358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91058.1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1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TTGCCGATGAATGGAGTCCTGT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TCTGTCTTGGTCATGCTGGTC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glA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53582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091059.1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6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CCGATCAGGAACTTGTCTAT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AAGTGGTGTAGGTCAGG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5048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p/fnr</a:t>
                      </a:r>
                      <a:r>
                        <a:rPr lang="en-US" sz="1200" i="1" baseline="-25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2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845_3156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8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AGGCAGCGCCTTGAACAGCTTGACC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ACATTTCCCGCCTGTCCGAAGCAGC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42" marR="4764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54649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2371444"/>
              </p:ext>
            </p:extLst>
          </p:nvPr>
        </p:nvGraphicFramePr>
        <p:xfrm>
          <a:off x="2385891" y="1479882"/>
          <a:ext cx="7030213" cy="3682745"/>
        </p:xfrm>
        <a:graphic>
          <a:graphicData uri="http://schemas.openxmlformats.org/drawingml/2006/table">
            <a:tbl>
              <a:tblPr firstRow="1" firstCol="1" bandRow="1"/>
              <a:tblGrid>
                <a:gridCol w="1263142"/>
                <a:gridCol w="789623"/>
                <a:gridCol w="1113473"/>
                <a:gridCol w="818515"/>
                <a:gridCol w="568960"/>
                <a:gridCol w="518160"/>
                <a:gridCol w="1958340"/>
              </a:tblGrid>
              <a:tr h="433139"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[Primer] (nM)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1200" b="1" baseline="-25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, opt. </a:t>
                      </a: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b="1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)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 (%)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b="1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CA" sz="1200" b="1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A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[Template] (dilution factor)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5">
                <a:tc rowSpan="2"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ference Genes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SrRN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9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5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yrB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6.7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6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1799">
                <a:tc rowSpan="8"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 Genes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A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6.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.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5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B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.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6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1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3911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C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1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5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sD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.8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83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5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mcA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6.7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4.5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7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3911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pA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.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84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5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glA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5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86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2855">
                <a:tc v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p/fnr</a:t>
                      </a:r>
                      <a:r>
                        <a:rPr lang="en-US" sz="1200" i="1" baseline="-250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.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3.1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CA" sz="12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7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385891" y="714084"/>
            <a:ext cx="7194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en-US" b="1" i="0" u="none" strike="noStrike" cap="none" normalizeH="0" baseline="0" dirty="0" smtClean="0" bmk="_Toc426505963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</a:t>
            </a:r>
            <a:r>
              <a:rPr kumimoji="0" lang="en-US" altLang="en-US" b="1" i="0" u="none" strike="noStrike" cap="none" normalizeH="0" dirty="0" smtClean="0" bmk="_Toc426505963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able 2. </a:t>
            </a:r>
            <a:r>
              <a:rPr kumimoji="0" lang="en-US" altLang="en-US" i="0" u="none" strike="noStrike" cap="none" normalizeH="0" baseline="0" dirty="0" smtClean="0" bmk="_Toc426505963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of RT-qPCR assay optimization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580335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03418" y="2318616"/>
            <a:ext cx="5695950" cy="1325563"/>
          </a:xfrm>
        </p:spPr>
        <p:txBody>
          <a:bodyPr/>
          <a:lstStyle/>
          <a:p>
            <a:r>
              <a:rPr lang="en-CA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  <a:endParaRPr lang="en-CA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733333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710" y="206821"/>
            <a:ext cx="6855130" cy="472201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43000" y="5073340"/>
            <a:ext cx="1012362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ple respons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ethylene. </a:t>
            </a:r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-C) illustrating the composition of each quadrant. Photographs (D-F) show the assay plates for the negative control (A, D), the positive control (B, E) and the experimental (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epho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, F) triple response. 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6425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43000" y="4705350"/>
            <a:ext cx="101236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ephon-derived ethylene causes an increase in the final pH of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. xylinu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oth cultures. Culture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grown i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 broth (pH 7) supplemented with ethephon and 0.2% (v/v)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ulase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incubated at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agitation at 150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m. Data was normaliz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,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expressed as percent of the untreat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Data presented indicates the final culture pH after 14 days of growth. Note that the y-axis begins at 50%. Erro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show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3). *** = p &lt; 0.001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4119" y="294894"/>
            <a:ext cx="6501384" cy="44104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55658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143000" y="4705350"/>
            <a:ext cx="101236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epho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es not affect the growth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. xylinu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en grow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agitated liquid culture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s were grown in the presence of ethephon that was added at the time of inoculation (A) and every 2 days (B)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legend indicates the ethephon concentrations tested. Culture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grown in a 96-well plate in SH broth (pH 7) supplemented with 0.4%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v/v)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ulase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cubated at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agitation at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rpm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ro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show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1079873" y="1343475"/>
            <a:ext cx="10249875" cy="2880000"/>
            <a:chOff x="1213847" y="832104"/>
            <a:chExt cx="10249874" cy="2880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3847" y="832104"/>
              <a:ext cx="5149874" cy="28800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63721" y="832104"/>
              <a:ext cx="5100000" cy="28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387091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curve (A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B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for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SrRNA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iciency (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) is shown in the standard curve. A singl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k in the melt-curve indicates the RT-qPCR reaction is specific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/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290318" y="1079903"/>
            <a:ext cx="11828986" cy="3312000"/>
            <a:chOff x="1420791" y="2235008"/>
            <a:chExt cx="8228859" cy="2304000"/>
          </a:xfrm>
        </p:grpSpPr>
        <p:pic>
          <p:nvPicPr>
            <p:cNvPr id="8" name="Picture 7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20791" y="2235008"/>
              <a:ext cx="4068000" cy="2304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81650" y="2235008"/>
              <a:ext cx="4068000" cy="2304000"/>
            </a:xfrm>
            <a:prstGeom prst="rect">
              <a:avLst/>
            </a:prstGeom>
          </p:spPr>
        </p:pic>
      </p:grpSp>
      <p:sp>
        <p:nvSpPr>
          <p:cNvPr id="2" name="TextBox 1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81643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yrB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378751" y="1071562"/>
            <a:ext cx="11652119" cy="3312000"/>
            <a:chOff x="1990701" y="1985962"/>
            <a:chExt cx="8105822" cy="230400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90701" y="1985962"/>
              <a:ext cx="4052911" cy="2304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43612" y="1985962"/>
              <a:ext cx="4052911" cy="2304000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04861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s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>
            <a:grpSpLocks noChangeAspect="1"/>
          </p:cNvGrpSpPr>
          <p:nvPr/>
        </p:nvGrpSpPr>
        <p:grpSpPr>
          <a:xfrm>
            <a:off x="378751" y="1019589"/>
            <a:ext cx="11652119" cy="3312000"/>
            <a:chOff x="1536343" y="1922165"/>
            <a:chExt cx="8105822" cy="2304000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36343" y="1922165"/>
              <a:ext cx="4045307" cy="23040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81650" y="1922165"/>
              <a:ext cx="4060515" cy="2304000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14630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43000" y="4705350"/>
            <a:ext cx="101236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(A) and melt-curve (B) analysi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sB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ime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t. Amplification efficiency (E) is shown in the standard curve. A single peak in the melt-curve indicates the RT-qPCR reaction is specific.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emplate controls (NTCs) produced no peak in th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t-curve (red line).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367820" y="1024158"/>
            <a:ext cx="11673981" cy="3312000"/>
            <a:chOff x="1859566" y="1805208"/>
            <a:chExt cx="8121030" cy="2304000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59566" y="1805208"/>
              <a:ext cx="4052911" cy="2304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12477" y="1805208"/>
              <a:ext cx="4068119" cy="230400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893618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62355" y="710571"/>
            <a:ext cx="498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65265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7C83FF161F3B841941599B364E7044C" ma:contentTypeVersion="7" ma:contentTypeDescription="Create a new document." ma:contentTypeScope="" ma:versionID="b335c58d47bbffc078f80549843333cf">
  <xsd:schema xmlns:xsd="http://www.w3.org/2001/XMLSchema" xmlns:p="http://schemas.microsoft.com/office/2006/metadata/properties" xmlns:ns2="3f9d1bc5-151b-4dd0-b288-06f212744711" targetNamespace="http://schemas.microsoft.com/office/2006/metadata/properties" ma:root="true" ma:fieldsID="46480fc9d121ec2d3a4c8722f7a88dd3" ns2:_="">
    <xsd:import namespace="3f9d1bc5-151b-4dd0-b288-06f212744711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f9d1bc5-151b-4dd0-b288-06f212744711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3f9d1bc5-151b-4dd0-b288-06f212744711">Presentation 1.PPTX</DocumentId>
    <IsDeleted xmlns="3f9d1bc5-151b-4dd0-b288-06f212744711">false</IsDeleted>
    <StageName xmlns="3f9d1bc5-151b-4dd0-b288-06f212744711" xsi:nil="true"/>
    <Checked_x0020_Out_x0020_To xmlns="3f9d1bc5-151b-4dd0-b288-06f212744711">
      <UserInfo>
        <DisplayName/>
        <AccountId xsi:nil="true"/>
        <AccountType/>
      </UserInfo>
    </Checked_x0020_Out_x0020_To>
    <DocumentType xmlns="3f9d1bc5-151b-4dd0-b288-06f212744711">Presentation</DocumentType>
    <FileFormat xmlns="3f9d1bc5-151b-4dd0-b288-06f212744711">PPTX</FileFormat>
    <TitleName xmlns="3f9d1bc5-151b-4dd0-b288-06f212744711">Presentation 1.PPTX</TitleName>
  </documentManagement>
</p:properties>
</file>

<file path=customXml/itemProps1.xml><?xml version="1.0" encoding="utf-8"?>
<ds:datastoreItem xmlns:ds="http://schemas.openxmlformats.org/officeDocument/2006/customXml" ds:itemID="{B2F9F649-1A81-4DA6-A750-E22F93F96313}"/>
</file>

<file path=customXml/itemProps2.xml><?xml version="1.0" encoding="utf-8"?>
<ds:datastoreItem xmlns:ds="http://schemas.openxmlformats.org/officeDocument/2006/customXml" ds:itemID="{BA9BB8B6-D440-406A-BF5A-DF0DE9FBC92B}"/>
</file>

<file path=customXml/itemProps3.xml><?xml version="1.0" encoding="utf-8"?>
<ds:datastoreItem xmlns:ds="http://schemas.openxmlformats.org/officeDocument/2006/customXml" ds:itemID="{E5ECA25F-33A2-4450-912D-8BBE0FE29B92}"/>
</file>

<file path=docProps/app.xml><?xml version="1.0" encoding="utf-8"?>
<Properties xmlns="http://schemas.openxmlformats.org/officeDocument/2006/extended-properties" xmlns:vt="http://schemas.openxmlformats.org/officeDocument/2006/docPropsVTypes">
  <TotalTime>11822</TotalTime>
  <Words>1371</Words>
  <Application>Microsoft Macintosh PowerPoint</Application>
  <PresentationFormat>Custom</PresentationFormat>
  <Paragraphs>186</Paragraphs>
  <Slides>1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Office Theme</vt:lpstr>
      <vt:lpstr>  Supplementary Material   The phytohormone ethylene enhances cellulose production, regulates CRP/FNR transcription, and causes differential gene expression within the bacterial cellulose synthesis operon of Komagataeibacter (Gluconacetobacter) xylinus ATCC 53582</vt:lpstr>
      <vt:lpstr>Supplementary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ry Tables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phytohormone ethylene enhances bacterial cellulose production, regulates CRP/FNR transcription, and causes differential gene expression within the cellulose synthesis operon of Komagataeibacter xylinus ATCC 53582</dc:title>
  <dc:creator>Richard</dc:creator>
  <cp:lastModifiedBy>Janice Strap</cp:lastModifiedBy>
  <cp:revision>38</cp:revision>
  <dcterms:created xsi:type="dcterms:W3CDTF">2015-09-16T04:42:33Z</dcterms:created>
  <dcterms:modified xsi:type="dcterms:W3CDTF">2015-11-18T22:55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7C83FF161F3B841941599B364E7044C</vt:lpwstr>
  </property>
</Properties>
</file>